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6" r:id="rId3"/>
    <p:sldId id="258" r:id="rId4"/>
    <p:sldId id="257" r:id="rId5"/>
    <p:sldId id="259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77" d="100"/>
          <a:sy n="77" d="100"/>
        </p:scale>
        <p:origin x="136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90842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94420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479443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10430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29918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3926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37444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4896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16964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9606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125941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6B57E1-F902-4C3E-9654-6AAAAA0496E5}" type="datetimeFigureOut">
              <a:rPr lang="en-GB" smtClean="0"/>
              <a:t>10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3D9BF2-63DB-494F-9AD2-AFFC423EC85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30868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4.emf"/><Relationship Id="rId13" Type="http://schemas.openxmlformats.org/officeDocument/2006/relationships/oleObject" Target="../embeddings/oleObject16.bin"/><Relationship Id="rId3" Type="http://schemas.openxmlformats.org/officeDocument/2006/relationships/oleObject" Target="../embeddings/oleObject11.bin"/><Relationship Id="rId7" Type="http://schemas.openxmlformats.org/officeDocument/2006/relationships/oleObject" Target="../embeddings/oleObject13.bin"/><Relationship Id="rId12" Type="http://schemas.openxmlformats.org/officeDocument/2006/relationships/image" Target="../media/image16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3.emf"/><Relationship Id="rId11" Type="http://schemas.openxmlformats.org/officeDocument/2006/relationships/oleObject" Target="../embeddings/oleObject15.bin"/><Relationship Id="rId5" Type="http://schemas.openxmlformats.org/officeDocument/2006/relationships/oleObject" Target="../embeddings/oleObject12.bin"/><Relationship Id="rId10" Type="http://schemas.openxmlformats.org/officeDocument/2006/relationships/image" Target="../media/image15.emf"/><Relationship Id="rId4" Type="http://schemas.openxmlformats.org/officeDocument/2006/relationships/image" Target="../media/image12.emf"/><Relationship Id="rId9" Type="http://schemas.openxmlformats.org/officeDocument/2006/relationships/oleObject" Target="../embeddings/oleObject14.bin"/><Relationship Id="rId14" Type="http://schemas.openxmlformats.org/officeDocument/2006/relationships/image" Target="../media/image17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432425" y="384813"/>
            <a:ext cx="1558926" cy="79375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u="sng" dirty="0" smtClean="0">
                <a:solidFill>
                  <a:schemeClr val="tx1"/>
                </a:solidFill>
              </a:rPr>
              <a:t>BR300 TMA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Patients (N=296) received adjuvant therapy. 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5" name="Rectangle 4"/>
          <p:cNvSpPr/>
          <p:nvPr/>
        </p:nvSpPr>
        <p:spPr>
          <a:xfrm>
            <a:off x="1432425" y="1885666"/>
            <a:ext cx="748021" cy="3982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STROM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N=262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2243330" y="1885666"/>
            <a:ext cx="748021" cy="3982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EPI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N=267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1432426" y="1223831"/>
            <a:ext cx="1558926" cy="6188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CTSS IHC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Matched Clinical data available for patients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434320" y="2337746"/>
            <a:ext cx="1557031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Patient outcome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Survival analysis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16" name="Rectangle 15"/>
          <p:cNvSpPr/>
          <p:nvPr/>
        </p:nvSpPr>
        <p:spPr>
          <a:xfrm>
            <a:off x="1432425" y="3611919"/>
            <a:ext cx="748800" cy="3982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STROM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N=69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17" name="Rectangle 16"/>
          <p:cNvSpPr/>
          <p:nvPr/>
        </p:nvSpPr>
        <p:spPr>
          <a:xfrm>
            <a:off x="2244109" y="3611919"/>
            <a:ext cx="748800" cy="3982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EPI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N=69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1433205" y="3109451"/>
            <a:ext cx="1558926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Subtype analysis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TNBC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3237326" y="2771051"/>
            <a:ext cx="1558800" cy="795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u="sng" dirty="0" smtClean="0">
                <a:solidFill>
                  <a:schemeClr val="tx1"/>
                </a:solidFill>
              </a:rPr>
              <a:t>Bespoke TNBC TMA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Patients (N=84)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Received adjuvant therapy</a:t>
            </a:r>
          </a:p>
        </p:txBody>
      </p:sp>
      <p:sp>
        <p:nvSpPr>
          <p:cNvPr id="27" name="Rectangle 26"/>
          <p:cNvSpPr/>
          <p:nvPr/>
        </p:nvSpPr>
        <p:spPr>
          <a:xfrm>
            <a:off x="3239095" y="3610525"/>
            <a:ext cx="748800" cy="399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STROM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N=84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28" name="Rectangle 27"/>
          <p:cNvSpPr/>
          <p:nvPr/>
        </p:nvSpPr>
        <p:spPr>
          <a:xfrm>
            <a:off x="4047326" y="3610525"/>
            <a:ext cx="748800" cy="399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EPI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N=84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29" name="Rectangle 28"/>
          <p:cNvSpPr/>
          <p:nvPr/>
        </p:nvSpPr>
        <p:spPr>
          <a:xfrm>
            <a:off x="82279" y="7118922"/>
            <a:ext cx="1321426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St. Gallen Subtype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Gene expression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3407955" y="5363265"/>
            <a:ext cx="1692275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Macrophage IHC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Buckley et al., 2016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1435099" y="4056013"/>
            <a:ext cx="1557031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Patient outcome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Survival analysis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3239095" y="4056013"/>
            <a:ext cx="1557031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Patient outcome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Survival analysis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37" name="Rectangle 36"/>
          <p:cNvSpPr/>
          <p:nvPr/>
        </p:nvSpPr>
        <p:spPr>
          <a:xfrm>
            <a:off x="2274567" y="5386213"/>
            <a:ext cx="748800" cy="39820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EPI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N=69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2774858" y="6065068"/>
            <a:ext cx="1321426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Macrophage gene signatures</a:t>
            </a:r>
            <a:endParaRPr lang="en-GB" sz="1000" dirty="0">
              <a:solidFill>
                <a:schemeClr val="tx1"/>
              </a:solidFill>
            </a:endParaRPr>
          </a:p>
        </p:txBody>
      </p:sp>
      <p:sp>
        <p:nvSpPr>
          <p:cNvPr id="39" name="Rectangle 38"/>
          <p:cNvSpPr/>
          <p:nvPr/>
        </p:nvSpPr>
        <p:spPr>
          <a:xfrm>
            <a:off x="1467607" y="7118922"/>
            <a:ext cx="1321426" cy="4572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Lehmann Analysis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Gene expression</a:t>
            </a:r>
            <a:endParaRPr lang="en-GB" sz="1000" dirty="0">
              <a:solidFill>
                <a:schemeClr val="tx1"/>
              </a:solidFill>
            </a:endParaRPr>
          </a:p>
        </p:txBody>
      </p:sp>
      <p:cxnSp>
        <p:nvCxnSpPr>
          <p:cNvPr id="41" name="Straight Arrow Connector 40"/>
          <p:cNvCxnSpPr>
            <a:endCxn id="37" idx="0"/>
          </p:cNvCxnSpPr>
          <p:nvPr/>
        </p:nvCxnSpPr>
        <p:spPr>
          <a:xfrm>
            <a:off x="2641600" y="4513213"/>
            <a:ext cx="0" cy="873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/>
          <p:nvPr/>
        </p:nvCxnSpPr>
        <p:spPr>
          <a:xfrm flipH="1" flipV="1">
            <a:off x="1002509" y="708664"/>
            <a:ext cx="0" cy="5578416"/>
          </a:xfrm>
          <a:prstGeom prst="straightConnector1">
            <a:avLst/>
          </a:prstGeom>
          <a:ln>
            <a:solidFill>
              <a:schemeClr val="tx1"/>
            </a:solidFill>
            <a:headEnd type="non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Connector 44"/>
          <p:cNvCxnSpPr/>
          <p:nvPr/>
        </p:nvCxnSpPr>
        <p:spPr>
          <a:xfrm flipH="1" flipV="1">
            <a:off x="1007158" y="708663"/>
            <a:ext cx="4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>
            <a:stCxn id="34" idx="3"/>
            <a:endCxn id="36" idx="1"/>
          </p:cNvCxnSpPr>
          <p:nvPr/>
        </p:nvCxnSpPr>
        <p:spPr>
          <a:xfrm>
            <a:off x="2992130" y="4284613"/>
            <a:ext cx="246965" cy="0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/>
          <p:cNvCxnSpPr>
            <a:endCxn id="29" idx="0"/>
          </p:cNvCxnSpPr>
          <p:nvPr/>
        </p:nvCxnSpPr>
        <p:spPr>
          <a:xfrm flipH="1">
            <a:off x="742992" y="6273800"/>
            <a:ext cx="259516" cy="845122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/>
          <p:cNvCxnSpPr>
            <a:endCxn id="39" idx="0"/>
          </p:cNvCxnSpPr>
          <p:nvPr/>
        </p:nvCxnSpPr>
        <p:spPr>
          <a:xfrm>
            <a:off x="1000666" y="6287081"/>
            <a:ext cx="1127654" cy="83184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/>
          <p:cNvCxnSpPr/>
          <p:nvPr/>
        </p:nvCxnSpPr>
        <p:spPr>
          <a:xfrm>
            <a:off x="1000666" y="6287081"/>
            <a:ext cx="177419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Rectangle 57"/>
          <p:cNvSpPr/>
          <p:nvPr/>
        </p:nvSpPr>
        <p:spPr>
          <a:xfrm>
            <a:off x="273318" y="5257531"/>
            <a:ext cx="1435100" cy="74046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u="sng" dirty="0" smtClean="0">
                <a:solidFill>
                  <a:schemeClr val="tx1"/>
                </a:solidFill>
              </a:rPr>
              <a:t>BR300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Gene expression data</a:t>
            </a:r>
          </a:p>
        </p:txBody>
      </p:sp>
      <p:cxnSp>
        <p:nvCxnSpPr>
          <p:cNvPr id="61" name="Straight Arrow Connector 60"/>
          <p:cNvCxnSpPr/>
          <p:nvPr/>
        </p:nvCxnSpPr>
        <p:spPr>
          <a:xfrm>
            <a:off x="3006864" y="5582191"/>
            <a:ext cx="404894" cy="3125"/>
          </a:xfrm>
          <a:prstGeom prst="straightConnector1">
            <a:avLst/>
          </a:prstGeom>
          <a:ln>
            <a:solidFill>
              <a:schemeClr val="tx1"/>
            </a:solidFill>
            <a:headEnd type="triangl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Rectangle 61"/>
          <p:cNvSpPr/>
          <p:nvPr/>
        </p:nvSpPr>
        <p:spPr>
          <a:xfrm>
            <a:off x="5041216" y="2771051"/>
            <a:ext cx="1558800" cy="7956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u="sng" dirty="0" smtClean="0">
                <a:solidFill>
                  <a:schemeClr val="tx1"/>
                </a:solidFill>
              </a:rPr>
              <a:t>Publicly available data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Overall survival N=1403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Relapse free survival N=3971</a:t>
            </a:r>
          </a:p>
        </p:txBody>
      </p:sp>
      <p:sp>
        <p:nvSpPr>
          <p:cNvPr id="80" name="Rectangle 79"/>
          <p:cNvSpPr/>
          <p:nvPr/>
        </p:nvSpPr>
        <p:spPr>
          <a:xfrm>
            <a:off x="5041216" y="3622821"/>
            <a:ext cx="1558800" cy="3166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Subtype analysis</a:t>
            </a:r>
          </a:p>
        </p:txBody>
      </p:sp>
      <p:sp>
        <p:nvSpPr>
          <p:cNvPr id="81" name="Rectangle 80"/>
          <p:cNvSpPr/>
          <p:nvPr/>
        </p:nvSpPr>
        <p:spPr>
          <a:xfrm>
            <a:off x="5041216" y="3983122"/>
            <a:ext cx="1558800" cy="102251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00" b="1" u="sng" dirty="0" smtClean="0">
                <a:solidFill>
                  <a:schemeClr val="tx1"/>
                </a:solidFill>
              </a:rPr>
              <a:t>OS and RFS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LUMINAL A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LUMINAL B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HER2+</a:t>
            </a:r>
          </a:p>
          <a:p>
            <a:pPr algn="ctr"/>
            <a:r>
              <a:rPr lang="en-GB" sz="1000" dirty="0" smtClean="0">
                <a:solidFill>
                  <a:schemeClr val="tx1"/>
                </a:solidFill>
              </a:rPr>
              <a:t>TNBC</a:t>
            </a:r>
          </a:p>
        </p:txBody>
      </p:sp>
      <p:cxnSp>
        <p:nvCxnSpPr>
          <p:cNvPr id="86" name="Straight Arrow Connector 85"/>
          <p:cNvCxnSpPr>
            <a:stCxn id="15" idx="2"/>
            <a:endCxn id="19" idx="0"/>
          </p:cNvCxnSpPr>
          <p:nvPr/>
        </p:nvCxnSpPr>
        <p:spPr>
          <a:xfrm flipH="1">
            <a:off x="2212668" y="2794946"/>
            <a:ext cx="168" cy="31450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Text Box 2"/>
          <p:cNvSpPr txBox="1">
            <a:spLocks noChangeArrowheads="1"/>
          </p:cNvSpPr>
          <p:nvPr/>
        </p:nvSpPr>
        <p:spPr bwMode="auto">
          <a:xfrm>
            <a:off x="107135" y="8707504"/>
            <a:ext cx="6616800" cy="276999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/>
            <a:r>
              <a:rPr lang="en-US" sz="1200" b="1" i="1" dirty="0"/>
              <a:t>Supplementary figure 1</a:t>
            </a:r>
            <a:r>
              <a:rPr lang="en-US" sz="1200" b="1" i="1" dirty="0" smtClean="0"/>
              <a:t>: Flow chart describing study design.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45388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 Box 2"/>
          <p:cNvSpPr txBox="1">
            <a:spLocks noChangeArrowheads="1"/>
          </p:cNvSpPr>
          <p:nvPr/>
        </p:nvSpPr>
        <p:spPr bwMode="auto">
          <a:xfrm>
            <a:off x="107135" y="8707504"/>
            <a:ext cx="6616800" cy="1015663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/>
            <a:r>
              <a:rPr lang="en-US" sz="1200" b="1" i="1" dirty="0"/>
              <a:t>Supplementary figure </a:t>
            </a:r>
            <a:r>
              <a:rPr lang="en-US" sz="1200" b="1" i="1" dirty="0" smtClean="0"/>
              <a:t>2:</a:t>
            </a:r>
            <a:r>
              <a:rPr lang="en-US" sz="1200" i="1" dirty="0" smtClean="0"/>
              <a:t> </a:t>
            </a:r>
            <a:r>
              <a:rPr lang="en-GB" sz="1200" b="1" i="1" dirty="0"/>
              <a:t>Breakdown of CTSS scores across subtypes and associated Kaplan-Meier OS figures. </a:t>
            </a:r>
            <a:r>
              <a:rPr lang="en-US" sz="1200" i="1" dirty="0"/>
              <a:t>a) Percentage breakdown of patients with high and low CTSS in </a:t>
            </a:r>
            <a:r>
              <a:rPr lang="en-US" sz="1200" i="1" dirty="0" err="1"/>
              <a:t>i</a:t>
            </a:r>
            <a:r>
              <a:rPr lang="en-US" sz="1200" i="1" dirty="0"/>
              <a:t>) epithelial and ii) stromal compartments. Kaplan-Meier curve of b) Luminal A, c) Luminal B/HER2-, d) Luminal B/HER2+, and e) HER2+ breast cancer subtypes overall survival (OS) stratified based on high or low CTSS expression in </a:t>
            </a:r>
            <a:r>
              <a:rPr lang="en-US" sz="1200" i="1" dirty="0" err="1"/>
              <a:t>i</a:t>
            </a:r>
            <a:r>
              <a:rPr lang="en-US" sz="1200" i="1" dirty="0"/>
              <a:t>) stromal and ii) epithelial compartment.</a:t>
            </a:r>
            <a:r>
              <a:rPr lang="en-GB" sz="1200" i="1" dirty="0"/>
              <a:t> Log-Rank p-value indicated. N=number of patients. </a:t>
            </a:r>
            <a:r>
              <a:rPr lang="fr-FR" sz="1200" dirty="0">
                <a:effectLst/>
                <a:ea typeface="Cambria" panose="020405030504060302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effectLst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473198"/>
              </p:ext>
            </p:extLst>
          </p:nvPr>
        </p:nvGraphicFramePr>
        <p:xfrm>
          <a:off x="1051751" y="348491"/>
          <a:ext cx="2250000" cy="1853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6" name="Prism 5" r:id="rId3" imgW="4366440" imgH="3596760" progId="Prism5.Document">
                  <p:embed/>
                </p:oleObj>
              </mc:Choice>
              <mc:Fallback>
                <p:oleObj name="Prism 5" r:id="rId3" imgW="4366440" imgH="35967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51751" y="348491"/>
                        <a:ext cx="2250000" cy="1853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0645878"/>
              </p:ext>
            </p:extLst>
          </p:nvPr>
        </p:nvGraphicFramePr>
        <p:xfrm>
          <a:off x="3547659" y="348162"/>
          <a:ext cx="2250000" cy="18533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7" name="Prism 5" r:id="rId5" imgW="4366440" imgH="3596760" progId="Prism5.Document">
                  <p:embed/>
                </p:oleObj>
              </mc:Choice>
              <mc:Fallback>
                <p:oleObj name="Prism 5" r:id="rId5" imgW="4366440" imgH="359676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47659" y="348162"/>
                        <a:ext cx="2250000" cy="18533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0156249"/>
              </p:ext>
            </p:extLst>
          </p:nvPr>
        </p:nvGraphicFramePr>
        <p:xfrm>
          <a:off x="1012832" y="2236648"/>
          <a:ext cx="244064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8" name="Prism 5" r:id="rId7" imgW="4366440" imgH="2898720" progId="Prism5.Document">
                  <p:embed/>
                </p:oleObj>
              </mc:Choice>
              <mc:Fallback>
                <p:oleObj name="Prism 5" r:id="rId7" imgW="436644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12832" y="2236648"/>
                        <a:ext cx="2440646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6838405"/>
              </p:ext>
            </p:extLst>
          </p:nvPr>
        </p:nvGraphicFramePr>
        <p:xfrm>
          <a:off x="3506345" y="2236648"/>
          <a:ext cx="244064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69" name="Prism 5" r:id="rId9" imgW="4366440" imgH="2898720" progId="Prism5.Document">
                  <p:embed/>
                </p:oleObj>
              </mc:Choice>
              <mc:Fallback>
                <p:oleObj name="Prism 5" r:id="rId9" imgW="436644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506345" y="2236648"/>
                        <a:ext cx="2440646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9583322"/>
              </p:ext>
            </p:extLst>
          </p:nvPr>
        </p:nvGraphicFramePr>
        <p:xfrm>
          <a:off x="1012832" y="3792240"/>
          <a:ext cx="244064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70" name="Prism 5" r:id="rId11" imgW="4366440" imgH="2898720" progId="Prism5.Document">
                  <p:embed/>
                </p:oleObj>
              </mc:Choice>
              <mc:Fallback>
                <p:oleObj name="Prism 5" r:id="rId11" imgW="436644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012832" y="3792240"/>
                        <a:ext cx="2440646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56245847"/>
              </p:ext>
            </p:extLst>
          </p:nvPr>
        </p:nvGraphicFramePr>
        <p:xfrm>
          <a:off x="3506345" y="3792240"/>
          <a:ext cx="244064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71" name="Prism 5" r:id="rId13" imgW="4366440" imgH="2898720" progId="Prism5.Document">
                  <p:embed/>
                </p:oleObj>
              </mc:Choice>
              <mc:Fallback>
                <p:oleObj name="Prism 5" r:id="rId13" imgW="436644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506345" y="3792240"/>
                        <a:ext cx="2440646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2989660"/>
              </p:ext>
            </p:extLst>
          </p:nvPr>
        </p:nvGraphicFramePr>
        <p:xfrm>
          <a:off x="1012832" y="5342275"/>
          <a:ext cx="244064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72" name="Prism 5" r:id="rId15" imgW="4366440" imgH="2898720" progId="Prism5.Document">
                  <p:embed/>
                </p:oleObj>
              </mc:Choice>
              <mc:Fallback>
                <p:oleObj name="Prism 5" r:id="rId15" imgW="436644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012832" y="5342275"/>
                        <a:ext cx="2440646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59630833"/>
              </p:ext>
            </p:extLst>
          </p:nvPr>
        </p:nvGraphicFramePr>
        <p:xfrm>
          <a:off x="3506345" y="5342275"/>
          <a:ext cx="244064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73" name="Prism 5" r:id="rId17" imgW="4366440" imgH="2898720" progId="Prism5.Document">
                  <p:embed/>
                </p:oleObj>
              </mc:Choice>
              <mc:Fallback>
                <p:oleObj name="Prism 5" r:id="rId17" imgW="436644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3506345" y="5342275"/>
                        <a:ext cx="2440646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2336124"/>
              </p:ext>
            </p:extLst>
          </p:nvPr>
        </p:nvGraphicFramePr>
        <p:xfrm>
          <a:off x="1017451" y="6889810"/>
          <a:ext cx="2430000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74" name="Prism 5" r:id="rId19" imgW="4348080" imgH="2898720" progId="Prism5.Document">
                  <p:embed/>
                </p:oleObj>
              </mc:Choice>
              <mc:Fallback>
                <p:oleObj name="Prism 5" r:id="rId19" imgW="434808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017451" y="6889810"/>
                        <a:ext cx="2430000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003939"/>
              </p:ext>
            </p:extLst>
          </p:nvPr>
        </p:nvGraphicFramePr>
        <p:xfrm>
          <a:off x="3506345" y="6889810"/>
          <a:ext cx="244064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75" name="Prism 5" r:id="rId21" imgW="4366440" imgH="2898720" progId="Prism5.Document">
                  <p:embed/>
                </p:oleObj>
              </mc:Choice>
              <mc:Fallback>
                <p:oleObj name="Prism 5" r:id="rId21" imgW="436644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506345" y="6889810"/>
                        <a:ext cx="2440646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/>
          <p:cNvSpPr txBox="1"/>
          <p:nvPr/>
        </p:nvSpPr>
        <p:spPr>
          <a:xfrm>
            <a:off x="684730" y="22893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75112" y="223664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921260" y="322338"/>
            <a:ext cx="229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err="1" smtClean="0"/>
              <a:t>i</a:t>
            </a:r>
            <a:endParaRPr lang="en-GB" sz="14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383699" y="322338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ii</a:t>
            </a:r>
            <a:endParaRPr lang="en-GB" sz="14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688738" y="3792240"/>
            <a:ext cx="2808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c</a:t>
            </a:r>
            <a:endParaRPr lang="en-GB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675112" y="5342275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d</a:t>
            </a:r>
            <a:endParaRPr lang="en-GB" b="1" dirty="0"/>
          </a:p>
        </p:txBody>
      </p:sp>
      <p:sp>
        <p:nvSpPr>
          <p:cNvPr id="22" name="TextBox 21"/>
          <p:cNvSpPr txBox="1"/>
          <p:nvPr/>
        </p:nvSpPr>
        <p:spPr>
          <a:xfrm>
            <a:off x="679120" y="688981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3383699" y="2292340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ii</a:t>
            </a:r>
            <a:endParaRPr lang="en-GB" sz="140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921260" y="2292340"/>
            <a:ext cx="229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i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383699" y="384793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ii</a:t>
            </a:r>
            <a:endParaRPr lang="en-GB" sz="140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921260" y="3847932"/>
            <a:ext cx="229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i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383699" y="5397967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ii</a:t>
            </a:r>
            <a:endParaRPr lang="en-GB" sz="14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921260" y="5397967"/>
            <a:ext cx="229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i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3383699" y="694550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/>
              <a:t>ii</a:t>
            </a:r>
            <a:endParaRPr lang="en-GB" sz="14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921260" y="6945502"/>
            <a:ext cx="2295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i</a:t>
            </a:r>
          </a:p>
        </p:txBody>
      </p:sp>
    </p:spTree>
    <p:extLst>
      <p:ext uri="{BB962C8B-B14F-4D97-AF65-F5344CB8AC3E}">
        <p14:creationId xmlns:p14="http://schemas.microsoft.com/office/powerpoint/2010/main" val="15963532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2"/>
          <p:cNvSpPr txBox="1">
            <a:spLocks noChangeArrowheads="1"/>
          </p:cNvSpPr>
          <p:nvPr/>
        </p:nvSpPr>
        <p:spPr bwMode="auto">
          <a:xfrm>
            <a:off x="132390" y="3978398"/>
            <a:ext cx="6616800" cy="830997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spcAft>
                <a:spcPts val="0"/>
              </a:spcAft>
            </a:pPr>
            <a:r>
              <a:rPr lang="en-US" sz="1200" b="1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Supplementary Figure </a:t>
            </a:r>
            <a:r>
              <a:rPr lang="en-US" sz="1200" b="1" i="1" dirty="0" smtClean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3: </a:t>
            </a:r>
            <a:r>
              <a:rPr lang="en-US" sz="1200" b="1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Complete Lehman analysis figure of subtype CTSS gene expression.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GB" sz="1200" b="1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GB" sz="1200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fr-FR" sz="1200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0" y="457201"/>
            <a:ext cx="3313531" cy="34499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208544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132390" y="5702301"/>
            <a:ext cx="6616800" cy="156966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Supplementary Figure </a:t>
            </a:r>
            <a:r>
              <a:rPr lang="en-US" sz="1200" b="1" i="1" dirty="0" smtClean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4: </a:t>
            </a:r>
            <a:r>
              <a:rPr lang="en-US" sz="1200" b="1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No effect on OS or RFS in total, Luminal A, or Luminal B breast cancer subtypes stratified by gene expression. </a:t>
            </a:r>
            <a:r>
              <a:rPr lang="en-US" sz="1200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Kaplan-Meier curves stratifying a) total breast cancer patient population, b) luminal A patient population, and c) luminal B patient population, based on high or low CTSS gene expression evaluating </a:t>
            </a:r>
            <a:r>
              <a:rPr lang="en-US" sz="1200" i="1" dirty="0" err="1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i</a:t>
            </a:r>
            <a:r>
              <a:rPr lang="en-US" sz="1200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) overall survival (OS) and ii) relapse free survival (RFS). </a:t>
            </a:r>
            <a:r>
              <a:rPr lang="en-GB" sz="1200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Log-rank p-value and hazard ratio (HR) indicated. N=number of patients.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GB" sz="1200" b="1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en-GB" sz="1200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fr-FR" sz="1200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4153091"/>
              </p:ext>
            </p:extLst>
          </p:nvPr>
        </p:nvGraphicFramePr>
        <p:xfrm>
          <a:off x="1109206" y="468524"/>
          <a:ext cx="2364843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8" name="Prism 5" r:id="rId3" imgW="3808440" imgH="2898720" progId="Prism5.Document">
                  <p:embed/>
                </p:oleObj>
              </mc:Choice>
              <mc:Fallback>
                <p:oleObj name="Prism 5" r:id="rId3" imgW="380844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09206" y="468524"/>
                        <a:ext cx="2364843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0547939"/>
              </p:ext>
            </p:extLst>
          </p:nvPr>
        </p:nvGraphicFramePr>
        <p:xfrm>
          <a:off x="3463139" y="448235"/>
          <a:ext cx="235301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9" name="Prism 5" r:id="rId5" imgW="3790080" imgH="2898720" progId="Prism5.Document">
                  <p:embed/>
                </p:oleObj>
              </mc:Choice>
              <mc:Fallback>
                <p:oleObj name="Prism 5" r:id="rId5" imgW="379008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63139" y="448235"/>
                        <a:ext cx="235301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30815136"/>
              </p:ext>
            </p:extLst>
          </p:nvPr>
        </p:nvGraphicFramePr>
        <p:xfrm>
          <a:off x="1109211" y="2185013"/>
          <a:ext cx="235301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0" name="Prism 5" r:id="rId7" imgW="3790080" imgH="2898720" progId="Prism5.Document">
                  <p:embed/>
                </p:oleObj>
              </mc:Choice>
              <mc:Fallback>
                <p:oleObj name="Prism 5" r:id="rId7" imgW="379008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109211" y="2185013"/>
                        <a:ext cx="235301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6388158"/>
              </p:ext>
            </p:extLst>
          </p:nvPr>
        </p:nvGraphicFramePr>
        <p:xfrm>
          <a:off x="1100085" y="3902301"/>
          <a:ext cx="2353010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1" name="Prism 5" r:id="rId9" imgW="3790080" imgH="2898720" progId="Prism5.Document">
                  <p:embed/>
                </p:oleObj>
              </mc:Choice>
              <mc:Fallback>
                <p:oleObj name="Prism 5" r:id="rId9" imgW="379008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100085" y="3902301"/>
                        <a:ext cx="2353010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6360005"/>
              </p:ext>
            </p:extLst>
          </p:nvPr>
        </p:nvGraphicFramePr>
        <p:xfrm>
          <a:off x="3454015" y="2185013"/>
          <a:ext cx="2353009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2" name="Prism 5" r:id="rId11" imgW="3790080" imgH="2898720" progId="Prism5.Document">
                  <p:embed/>
                </p:oleObj>
              </mc:Choice>
              <mc:Fallback>
                <p:oleObj name="Prism 5" r:id="rId11" imgW="379008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454015" y="2185013"/>
                        <a:ext cx="2353009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24160825"/>
              </p:ext>
            </p:extLst>
          </p:nvPr>
        </p:nvGraphicFramePr>
        <p:xfrm>
          <a:off x="3454008" y="3902300"/>
          <a:ext cx="2364843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3" name="Prism 5" r:id="rId13" imgW="3808440" imgH="2898720" progId="Prism5.Document">
                  <p:embed/>
                </p:oleObj>
              </mc:Choice>
              <mc:Fallback>
                <p:oleObj name="Prism 5" r:id="rId13" imgW="3808440" imgH="289872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454008" y="3902300"/>
                        <a:ext cx="2364843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947729" y="413768"/>
            <a:ext cx="2600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a</a:t>
            </a:r>
            <a:endParaRPr lang="en-GB" sz="12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3465008" y="41376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ii</a:t>
            </a:r>
            <a:endParaRPr lang="en-GB" sz="1200" b="1" dirty="0"/>
          </a:p>
        </p:txBody>
      </p:sp>
      <p:sp>
        <p:nvSpPr>
          <p:cNvPr id="15" name="TextBox 14"/>
          <p:cNvSpPr txBox="1"/>
          <p:nvPr/>
        </p:nvSpPr>
        <p:spPr>
          <a:xfrm>
            <a:off x="943722" y="2120114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b</a:t>
            </a:r>
            <a:endParaRPr lang="en-GB" sz="12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3465008" y="2120114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ii</a:t>
            </a:r>
            <a:endParaRPr lang="en-GB" sz="12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953340" y="3857690"/>
            <a:ext cx="2487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c</a:t>
            </a:r>
            <a:endParaRPr lang="en-GB" sz="12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3465008" y="385769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/>
              <a:t>ii</a:t>
            </a:r>
            <a:endParaRPr lang="en-GB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1096122" y="413768"/>
            <a:ext cx="223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/>
              <a:t>i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096122" y="2120114"/>
            <a:ext cx="223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err="1" smtClean="0"/>
              <a:t>i</a:t>
            </a:r>
            <a:endParaRPr lang="en-GB" sz="1200" b="1" dirty="0"/>
          </a:p>
        </p:txBody>
      </p:sp>
      <p:sp>
        <p:nvSpPr>
          <p:cNvPr id="21" name="TextBox 20"/>
          <p:cNvSpPr txBox="1"/>
          <p:nvPr/>
        </p:nvSpPr>
        <p:spPr>
          <a:xfrm>
            <a:off x="1096122" y="3857690"/>
            <a:ext cx="2231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err="1" smtClean="0"/>
              <a:t>i</a:t>
            </a:r>
            <a:endParaRPr lang="en-GB" sz="1200" b="1" dirty="0"/>
          </a:p>
        </p:txBody>
      </p:sp>
    </p:spTree>
    <p:extLst>
      <p:ext uri="{BB962C8B-B14F-4D97-AF65-F5344CB8AC3E}">
        <p14:creationId xmlns:p14="http://schemas.microsoft.com/office/powerpoint/2010/main" val="213868115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2"/>
          <p:cNvSpPr txBox="1">
            <a:spLocks noChangeArrowheads="1"/>
          </p:cNvSpPr>
          <p:nvPr/>
        </p:nvSpPr>
        <p:spPr bwMode="auto">
          <a:xfrm>
            <a:off x="161450" y="3065976"/>
            <a:ext cx="6616800" cy="1351280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200" b="1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Supplementary Table 1: Increased CTSS gene expression associated with improved survival in HER2+ and Triple Negative breast cancers. </a:t>
            </a:r>
            <a:r>
              <a:rPr lang="en-US" sz="1200" i="1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Analysis of publicly available gene expression data with matching clinical outcome from KM plotter revealed a significant association of increased CTSS expression with improved overall survival and relapse free survival. N=number of patients. HR=Cox proportional hazard ratio. CI=95% confidence intervals.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  <a:p>
            <a:pPr algn="just">
              <a:spcAft>
                <a:spcPts val="0"/>
              </a:spcAft>
            </a:pPr>
            <a:r>
              <a:rPr lang="fr-FR" sz="1200" dirty="0">
                <a:effectLst/>
                <a:latin typeface="Cambria" panose="02040503050406030204" pitchFamily="18" charset="0"/>
                <a:ea typeface="Cambria" panose="02040503050406030204" pitchFamily="18" charset="0"/>
                <a:cs typeface="Arial" panose="020B0604020202020204" pitchFamily="34" charset="0"/>
              </a:rPr>
              <a:t> </a:t>
            </a:r>
            <a:endParaRPr lang="en-GB" sz="1200" dirty="0">
              <a:effectLst/>
              <a:latin typeface="Cambria" panose="02040503050406030204" pitchFamily="18" charset="0"/>
              <a:ea typeface="Cambria" panose="02040503050406030204" pitchFamily="18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23994104"/>
              </p:ext>
            </p:extLst>
          </p:nvPr>
        </p:nvGraphicFramePr>
        <p:xfrm>
          <a:off x="512338" y="972620"/>
          <a:ext cx="5915023" cy="1496482"/>
        </p:xfrm>
        <a:graphic>
          <a:graphicData uri="http://schemas.openxmlformats.org/drawingml/2006/table">
            <a:tbl>
              <a:tblPr/>
              <a:tblGrid>
                <a:gridCol w="830179"/>
                <a:gridCol w="485958"/>
                <a:gridCol w="690972"/>
                <a:gridCol w="485958"/>
                <a:gridCol w="688346"/>
                <a:gridCol w="40592"/>
                <a:gridCol w="131613"/>
                <a:gridCol w="485958"/>
                <a:gridCol w="769434"/>
                <a:gridCol w="485958"/>
                <a:gridCol w="820055"/>
              </a:tblGrid>
              <a:tr h="159523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909"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verall survival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lapse free survival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</a:tr>
              <a:tr h="18990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R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I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8990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03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-1.36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71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8-1.09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8990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minal A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61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6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-1.37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33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6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9-1.26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90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uminal B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3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3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-1.93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49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6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-1.01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8990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ER2+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7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1**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0-0.72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1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2***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7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2-0.70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7505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NBC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1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9***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7-0.71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18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&lt;0.0001***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6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6-0.60</a:t>
                      </a:r>
                    </a:p>
                  </a:txBody>
                  <a:tcPr marL="7596" marR="7596" marT="7596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324409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</TotalTime>
  <Words>469</Words>
  <Application>Microsoft Office PowerPoint</Application>
  <PresentationFormat>A4 Paper (210x297 mm)</PresentationFormat>
  <Paragraphs>151</Paragraphs>
  <Slides>5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Cambria</vt:lpstr>
      <vt:lpstr>Office Theme</vt:lpstr>
      <vt:lpstr>Prism 5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edicine, Dentistry and Biomedical Scienc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chard Wilkinson</dc:creator>
  <cp:lastModifiedBy>Richard Wilkinson</cp:lastModifiedBy>
  <cp:revision>19</cp:revision>
  <dcterms:created xsi:type="dcterms:W3CDTF">2019-04-11T10:57:37Z</dcterms:created>
  <dcterms:modified xsi:type="dcterms:W3CDTF">2019-06-10T09:06:38Z</dcterms:modified>
</cp:coreProperties>
</file>